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4676"/>
  </p:normalViewPr>
  <p:slideViewPr>
    <p:cSldViewPr>
      <p:cViewPr varScale="1">
        <p:scale>
          <a:sx n="97" d="100"/>
          <a:sy n="97" d="100"/>
        </p:scale>
        <p:origin x="1544" y="20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A4E065-8520-F64E-A881-200997750001}" type="datetimeFigureOut">
              <a:rPr lang="en-US" smtClean="0"/>
              <a:t>11/24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811691-17ED-5A41-AA5F-3C189BD65A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090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de ondertitelstijl van het mod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24DC-D5EF-4AC6-91DF-02B50D99D3FC}" type="datetimeFigureOut">
              <a:rPr lang="nl-NL" smtClean="0"/>
              <a:t>24-11-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2083F-4D98-4313-B55B-770781E7CFC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679639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24DC-D5EF-4AC6-91DF-02B50D99D3FC}" type="datetimeFigureOut">
              <a:rPr lang="nl-NL" smtClean="0"/>
              <a:t>24-11-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2083F-4D98-4313-B55B-770781E7CFC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67157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24DC-D5EF-4AC6-91DF-02B50D99D3FC}" type="datetimeFigureOut">
              <a:rPr lang="nl-NL" smtClean="0"/>
              <a:t>24-11-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2083F-4D98-4313-B55B-770781E7CFC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80873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24DC-D5EF-4AC6-91DF-02B50D99D3FC}" type="datetimeFigureOut">
              <a:rPr lang="nl-NL" smtClean="0"/>
              <a:t>24-11-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2083F-4D98-4313-B55B-770781E7CFC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217600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24DC-D5EF-4AC6-91DF-02B50D99D3FC}" type="datetimeFigureOut">
              <a:rPr lang="nl-NL" smtClean="0"/>
              <a:t>24-11-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2083F-4D98-4313-B55B-770781E7CFC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17805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24DC-D5EF-4AC6-91DF-02B50D99D3FC}" type="datetimeFigureOut">
              <a:rPr lang="nl-NL" smtClean="0"/>
              <a:t>24-11-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2083F-4D98-4313-B55B-770781E7CFC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10190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24DC-D5EF-4AC6-91DF-02B50D99D3FC}" type="datetimeFigureOut">
              <a:rPr lang="nl-NL" smtClean="0"/>
              <a:t>24-11-16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2083F-4D98-4313-B55B-770781E7CFC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733576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24DC-D5EF-4AC6-91DF-02B50D99D3FC}" type="datetimeFigureOut">
              <a:rPr lang="nl-NL" smtClean="0"/>
              <a:t>24-11-16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2083F-4D98-4313-B55B-770781E7CFC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218875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24DC-D5EF-4AC6-91DF-02B50D99D3FC}" type="datetimeFigureOut">
              <a:rPr lang="nl-NL" smtClean="0"/>
              <a:t>24-11-16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2083F-4D98-4313-B55B-770781E7CFC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361906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24DC-D5EF-4AC6-91DF-02B50D99D3FC}" type="datetimeFigureOut">
              <a:rPr lang="nl-NL" smtClean="0"/>
              <a:t>24-11-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2083F-4D98-4313-B55B-770781E7CFC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961428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C24DC-D5EF-4AC6-91DF-02B50D99D3FC}" type="datetimeFigureOut">
              <a:rPr lang="nl-NL" smtClean="0"/>
              <a:t>24-11-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2083F-4D98-4313-B55B-770781E7CFC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41677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6C24DC-D5EF-4AC6-91DF-02B50D99D3FC}" type="datetimeFigureOut">
              <a:rPr lang="nl-NL" smtClean="0"/>
              <a:t>24-11-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E2083F-4D98-4313-B55B-770781E7CFC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19870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hoek 3"/>
          <p:cNvSpPr/>
          <p:nvPr/>
        </p:nvSpPr>
        <p:spPr>
          <a:xfrm>
            <a:off x="539552" y="1412776"/>
            <a:ext cx="8064896" cy="475252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 dirty="0"/>
          </a:p>
        </p:txBody>
      </p:sp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Attributes</a:t>
            </a:r>
            <a:endParaRPr lang="nl-NL" dirty="0"/>
          </a:p>
        </p:txBody>
      </p:sp>
      <p:sp>
        <p:nvSpPr>
          <p:cNvPr id="5" name="Tekstvak 4"/>
          <p:cNvSpPr txBox="1"/>
          <p:nvPr/>
        </p:nvSpPr>
        <p:spPr>
          <a:xfrm>
            <a:off x="856364" y="1628800"/>
            <a:ext cx="124688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ositive</a:t>
            </a:r>
          </a:p>
          <a:p>
            <a:r>
              <a:rPr lang="en-US" dirty="0" smtClean="0">
                <a:solidFill>
                  <a:srgbClr val="FF0000"/>
                </a:solidFill>
              </a:rPr>
              <a:t>Monogamy</a:t>
            </a:r>
            <a:endParaRPr lang="nl-NL" dirty="0">
              <a:solidFill>
                <a:srgbClr val="FF0000"/>
              </a:solidFill>
            </a:endParaRPr>
          </a:p>
        </p:txBody>
      </p:sp>
      <p:sp>
        <p:nvSpPr>
          <p:cNvPr id="6" name="Tekstvak 5"/>
          <p:cNvSpPr txBox="1"/>
          <p:nvPr/>
        </p:nvSpPr>
        <p:spPr>
          <a:xfrm>
            <a:off x="6660232" y="1628800"/>
            <a:ext cx="181402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Negative</a:t>
            </a:r>
          </a:p>
          <a:p>
            <a:r>
              <a:rPr lang="en-US" dirty="0" smtClean="0">
                <a:solidFill>
                  <a:srgbClr val="FF0000"/>
                </a:solidFill>
              </a:rPr>
              <a:t>Multiple Partners</a:t>
            </a:r>
            <a:endParaRPr lang="nl-NL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994825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imuli - Monogamy</a:t>
            </a:r>
            <a:endParaRPr lang="nl-NL" dirty="0"/>
          </a:p>
        </p:txBody>
      </p:sp>
      <p:pic>
        <p:nvPicPr>
          <p:cNvPr id="4" name="Tijdelijke aanduiding voor inhoud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592" y="1556792"/>
            <a:ext cx="2592288" cy="2460848"/>
          </a:xfrm>
        </p:spPr>
      </p:pic>
      <p:pic>
        <p:nvPicPr>
          <p:cNvPr id="5" name="Afbeelding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6056" y="1556792"/>
            <a:ext cx="2266950" cy="2381250"/>
          </a:xfrm>
          <a:prstGeom prst="rect">
            <a:avLst/>
          </a:prstGeom>
        </p:spPr>
      </p:pic>
      <p:pic>
        <p:nvPicPr>
          <p:cNvPr id="6" name="Afbeelding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608" y="4195949"/>
            <a:ext cx="2329805" cy="2481449"/>
          </a:xfrm>
          <a:prstGeom prst="rect">
            <a:avLst/>
          </a:prstGeom>
        </p:spPr>
      </p:pic>
      <p:pic>
        <p:nvPicPr>
          <p:cNvPr id="8" name="Afbeelding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4296" y="4077072"/>
            <a:ext cx="1938710" cy="23250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04451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imuli – Multiple Partners</a:t>
            </a:r>
            <a:endParaRPr lang="nl-NL" dirty="0"/>
          </a:p>
        </p:txBody>
      </p:sp>
      <p:pic>
        <p:nvPicPr>
          <p:cNvPr id="4" name="Afbeelding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9832" y="1438350"/>
            <a:ext cx="3410956" cy="2196999"/>
          </a:xfrm>
          <a:prstGeom prst="rect">
            <a:avLst/>
          </a:prstGeom>
        </p:spPr>
      </p:pic>
      <p:pic>
        <p:nvPicPr>
          <p:cNvPr id="5" name="Afbeelding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567" y="3317455"/>
            <a:ext cx="1841567" cy="3142356"/>
          </a:xfrm>
          <a:prstGeom prst="rect">
            <a:avLst/>
          </a:prstGeom>
        </p:spPr>
      </p:pic>
      <p:pic>
        <p:nvPicPr>
          <p:cNvPr id="6" name="Afbeelding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2996" y="3717032"/>
            <a:ext cx="3035481" cy="2725105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6056" y="1464828"/>
            <a:ext cx="3189362" cy="21440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67191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imuli - Positive</a:t>
            </a:r>
            <a:endParaRPr lang="nl-NL" dirty="0"/>
          </a:p>
        </p:txBody>
      </p:sp>
      <p:pic>
        <p:nvPicPr>
          <p:cNvPr id="4" name="Afbeelding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67945" y="1340769"/>
            <a:ext cx="4730115" cy="1853020"/>
          </a:xfrm>
          <a:prstGeom prst="rect">
            <a:avLst/>
          </a:prstGeom>
        </p:spPr>
      </p:pic>
      <p:pic>
        <p:nvPicPr>
          <p:cNvPr id="5" name="Afbeelding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9127" y="3568948"/>
            <a:ext cx="4248933" cy="2102693"/>
          </a:xfrm>
          <a:prstGeom prst="rect">
            <a:avLst/>
          </a:prstGeom>
        </p:spPr>
      </p:pic>
      <p:pic>
        <p:nvPicPr>
          <p:cNvPr id="6" name="Afbeelding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29" y="3568949"/>
            <a:ext cx="4248932" cy="2102693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29" y="1340768"/>
            <a:ext cx="3744416" cy="18530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57565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imuli - Negative</a:t>
            </a:r>
            <a:endParaRPr lang="nl-NL" dirty="0"/>
          </a:p>
        </p:txBody>
      </p:sp>
      <p:pic>
        <p:nvPicPr>
          <p:cNvPr id="4" name="Afbeelding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9992" y="1340768"/>
            <a:ext cx="4206843" cy="2081864"/>
          </a:xfrm>
          <a:prstGeom prst="rect">
            <a:avLst/>
          </a:prstGeom>
        </p:spPr>
      </p:pic>
      <p:pic>
        <p:nvPicPr>
          <p:cNvPr id="5" name="Afbeelding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264" y="1340768"/>
            <a:ext cx="4206843" cy="2081864"/>
          </a:xfrm>
          <a:prstGeom prst="rect">
            <a:avLst/>
          </a:prstGeom>
        </p:spPr>
      </p:pic>
      <p:pic>
        <p:nvPicPr>
          <p:cNvPr id="6" name="Afbeelding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0400" y="3901139"/>
            <a:ext cx="4206843" cy="2081864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560" y="3901139"/>
            <a:ext cx="4206843" cy="20818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4320844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3</TotalTime>
  <Words>19</Words>
  <Application>Microsoft Macintosh PowerPoint</Application>
  <PresentationFormat>On-screen Show (4:3)</PresentationFormat>
  <Paragraphs>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Kantoorthema</vt:lpstr>
      <vt:lpstr>Attributes</vt:lpstr>
      <vt:lpstr>Stimuli - Monogamy</vt:lpstr>
      <vt:lpstr>Stimuli – Multiple Partners</vt:lpstr>
      <vt:lpstr>Stimuli - Positive</vt:lpstr>
      <vt:lpstr>Stimuli - Negative</vt:lpstr>
    </vt:vector>
  </TitlesOfParts>
  <Company>Open Universiteit</Company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AT Design</dc:title>
  <dc:creator>Wolfs, Kenny</dc:creator>
  <cp:lastModifiedBy>Chris Kenyon</cp:lastModifiedBy>
  <cp:revision>4</cp:revision>
  <cp:lastPrinted>2016-11-24T13:00:28Z</cp:lastPrinted>
  <dcterms:created xsi:type="dcterms:W3CDTF">2014-12-17T08:24:08Z</dcterms:created>
  <dcterms:modified xsi:type="dcterms:W3CDTF">2016-11-24T18:51:53Z</dcterms:modified>
</cp:coreProperties>
</file>